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396" autoAdjust="0"/>
    <p:restoredTop sz="94643"/>
  </p:normalViewPr>
  <p:slideViewPr>
    <p:cSldViewPr snapToGrid="0" snapToObjects="1">
      <p:cViewPr varScale="1">
        <p:scale>
          <a:sx n="128" d="100"/>
          <a:sy n="128" d="100"/>
        </p:scale>
        <p:origin x="14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F141C1-909C-E64D-98A8-61FCB3A746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074B28-F198-1143-BD27-C16A038D4B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856B31-64B7-FA49-AE92-825016942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3D9687-9DD7-FB43-AB12-6C34754FA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13333E-D66A-BA49-9E71-E8876876A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183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16921-FF1B-D644-8ED3-3AB44F628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147F54-B737-9343-90D2-40311D263B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1E8276-984F-E241-9E8F-26DE0FAD7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C114BD-03F8-454A-8357-9E4596A12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F9585-052B-C046-B0CC-4A6E9D251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080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54895D-DE20-3D43-A834-2D47D6D9DF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7C704F-7C07-7146-B1B9-6B1A63F1F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AAC5EE-7D03-114E-8A6E-F87EACE1E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245D82-7CF0-9F40-AABD-5752E0576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4D9C8E-FFD2-BE46-8D7E-703CA682A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677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BEEE20-CD0A-2742-8A47-FE31E77F8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B81853-9184-8440-BB2E-9A48FD931E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807DA-097F-734B-8D1F-25908F0D1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0EE291-2839-CA4E-B051-13854CECE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089D8-8196-D24D-861F-AD2BB18E9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51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DD44A-0621-5F47-9836-618541B7E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A05F84-E820-574F-9581-B0EE7F4919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305122-E80C-1F4D-8525-837CEFDFE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AA259-6BB7-F84D-8F40-F5743AA9F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23CD9D-6586-2346-BCBD-2B5D976A2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752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0946B-59BA-2F4E-80F0-CAA562D554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3CE45C-E302-6946-9C74-7444D86F48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1146C4-7688-254A-89E5-92BA19CDBC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E1C8EE-4474-0D43-A010-1512CD6F7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DCFC07-3EE0-904A-9BD8-2EB67A4D8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9E50D2-A9E4-5B40-A78C-399EFC5F6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213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6C1D3E-7943-D64B-9723-4726135CE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D2C548-062B-754C-A53B-D62143CDA2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B22967-F8B6-C04E-9D5F-66CAE2479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A362D8-8635-7442-B670-E424263510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803DDB-BEAA-C24E-88B5-0FD7F2DC27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361A74-804E-3A41-8C4A-0F999AC4F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B913E2-14FF-404F-843E-8FAE536C6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CB124B-D5E0-1E4C-A456-EEBA33CA5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424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4A829-2CAF-9340-AA82-3E7F39B1A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0B13EA-1835-724C-A6D5-B7076AE3A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6DCE08-D5E0-DB45-86EF-6E1CA208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C90BC8-F303-3243-9E06-BA27B6D39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680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64B80D-82B1-9040-9A27-79553C3FC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7C6779-1002-4545-BC26-03903C2A4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48F41E-9E5D-7E46-BFB3-7F2D4C275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376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949A2-A30B-484B-96EA-2AD5592740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256F34-6051-BF41-BC0D-3FD9A71D27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B2EDA2-14DE-4741-9AAB-278E096AF8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2DCC8C-8418-5F4F-81EB-6F5C27709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D73977-8E18-CE45-BFAB-55D3C33C7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874E8B-0741-F349-95B7-B9EDD7193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979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A2045B-A0F0-C34D-B21F-4545563C0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B8F47C-ED61-A548-8D78-B312186137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ACAA1F-4A6E-2D44-844D-7A8BB153A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FB027C-112B-AE43-A253-0CC1BC4C0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CCA62-6E18-144D-BCA3-1EEAFEBB9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E9B6E4-52A6-AE49-86FC-45FE32EAC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703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E3B5E9-6AFA-FE4D-8C63-9A39B3F22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5F831D-72B9-F94D-854F-ADF48D9AA5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5AB8A-99E5-F447-86AF-6B897D742E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B06E2-520A-1844-A2BF-CC287684AEF9}" type="datetimeFigureOut">
              <a:rPr lang="en-US" smtClean="0"/>
              <a:t>3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3BAF89-FF5D-774A-96A6-101B5FC3AB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232966-2E44-B641-93F1-08EA52EA7E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C0597-342F-7441-AA0E-DE69EEE3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055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microsoft.com/office/2007/relationships/hdphoto" Target="../media/hdphoto2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014A9-C0C1-C54A-81ED-28CBEB7B5F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7521" y="170822"/>
            <a:ext cx="6166901" cy="384926"/>
          </a:xfrm>
        </p:spPr>
        <p:txBody>
          <a:bodyPr>
            <a:normAutofit/>
          </a:bodyPr>
          <a:lstStyle/>
          <a:p>
            <a:r>
              <a:rPr lang="en-US" sz="2000" dirty="0"/>
              <a:t>Supplementary material - Original western blots (Fig. 4)</a:t>
            </a:r>
          </a:p>
        </p:txBody>
      </p:sp>
      <p:sp>
        <p:nvSpPr>
          <p:cNvPr id="6" name="TextBox 4">
            <a:extLst>
              <a:ext uri="{FF2B5EF4-FFF2-40B4-BE49-F238E27FC236}">
                <a16:creationId xmlns:a16="http://schemas.microsoft.com/office/drawing/2014/main" id="{9204000A-7ABB-BA42-ACF1-C4D084A8F33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7567" y="3110226"/>
            <a:ext cx="41229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/>
              <a:t>NO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375767-B907-444B-97C6-C3388ED26AD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00103" y="2937742"/>
            <a:ext cx="77457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NOR+rytvela</a:t>
            </a:r>
            <a:endParaRPr lang="fr-CA" altLang="en-US" sz="800" dirty="0"/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id="{793C23D4-82D2-874F-BA65-027F162C4DD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03525" y="2932570"/>
            <a:ext cx="7986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NOR+Kineret</a:t>
            </a:r>
            <a:endParaRPr lang="fr-CA" altLang="en-US" sz="800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E465995B-3569-7745-863E-1AAA9DB6DB1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91035" y="3141166"/>
            <a:ext cx="36740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/>
              <a:t>OIR</a:t>
            </a:r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id="{AC00AC55-AA31-CC47-BC9F-F4E8C6D7DE0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95633" y="2962752"/>
            <a:ext cx="72968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OIR+rytvela</a:t>
            </a:r>
            <a:endParaRPr lang="fr-CA" altLang="en-US" sz="800" dirty="0"/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id="{61EA2AAB-4CA8-F74F-B153-9715CFE6CE2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00417" y="2957622"/>
            <a:ext cx="7537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OIR+Kineret</a:t>
            </a:r>
            <a:endParaRPr lang="fr-CA" altLang="en-US" sz="800" dirty="0"/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id="{8BE986C3-FC7E-BB47-8FF0-FC56AB6E795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14930" y="3127918"/>
            <a:ext cx="41229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/>
              <a:t>NOR</a:t>
            </a:r>
          </a:p>
        </p:txBody>
      </p:sp>
      <p:sp>
        <p:nvSpPr>
          <p:cNvPr id="14" name="TextBox 4">
            <a:extLst>
              <a:ext uri="{FF2B5EF4-FFF2-40B4-BE49-F238E27FC236}">
                <a16:creationId xmlns:a16="http://schemas.microsoft.com/office/drawing/2014/main" id="{75A441BC-B9A1-8544-B3EE-5C19CA51B3E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08416" y="2955434"/>
            <a:ext cx="77457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NOR+rytvela</a:t>
            </a:r>
            <a:endParaRPr lang="fr-CA" altLang="en-US" sz="800" dirty="0"/>
          </a:p>
        </p:txBody>
      </p:sp>
      <p:sp>
        <p:nvSpPr>
          <p:cNvPr id="15" name="TextBox 4">
            <a:extLst>
              <a:ext uri="{FF2B5EF4-FFF2-40B4-BE49-F238E27FC236}">
                <a16:creationId xmlns:a16="http://schemas.microsoft.com/office/drawing/2014/main" id="{CCE57049-6300-1542-95BB-742EB13AB41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78957" y="2950625"/>
            <a:ext cx="7986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NOR+Kineret</a:t>
            </a:r>
            <a:endParaRPr lang="fr-CA" altLang="en-US" sz="800" dirty="0"/>
          </a:p>
        </p:txBody>
      </p:sp>
      <p:sp>
        <p:nvSpPr>
          <p:cNvPr id="16" name="TextBox 4">
            <a:extLst>
              <a:ext uri="{FF2B5EF4-FFF2-40B4-BE49-F238E27FC236}">
                <a16:creationId xmlns:a16="http://schemas.microsoft.com/office/drawing/2014/main" id="{9225744F-A0F1-9743-AD01-CC1FA81CE65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81886" y="3148919"/>
            <a:ext cx="36740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/>
              <a:t>OIR</a:t>
            </a:r>
          </a:p>
        </p:txBody>
      </p:sp>
      <p:sp>
        <p:nvSpPr>
          <p:cNvPr id="17" name="TextBox 4">
            <a:extLst>
              <a:ext uri="{FF2B5EF4-FFF2-40B4-BE49-F238E27FC236}">
                <a16:creationId xmlns:a16="http://schemas.microsoft.com/office/drawing/2014/main" id="{7A5BACBA-8BD4-F04D-9CC9-AE3245D1B6F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92833" y="2973067"/>
            <a:ext cx="72968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OIR+rytvela</a:t>
            </a:r>
            <a:endParaRPr lang="fr-CA" altLang="en-US" sz="800" dirty="0"/>
          </a:p>
        </p:txBody>
      </p:sp>
      <p:sp>
        <p:nvSpPr>
          <p:cNvPr id="18" name="TextBox 4">
            <a:extLst>
              <a:ext uri="{FF2B5EF4-FFF2-40B4-BE49-F238E27FC236}">
                <a16:creationId xmlns:a16="http://schemas.microsoft.com/office/drawing/2014/main" id="{B90D46A1-C03B-454D-BD91-CB4BAF43189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98751" y="2955757"/>
            <a:ext cx="7537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OIR+Kineret</a:t>
            </a:r>
            <a:endParaRPr lang="fr-CA" altLang="en-US" sz="800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D6E14C3-C137-C040-B975-CAE8CF3D1AB2}"/>
              </a:ext>
            </a:extLst>
          </p:cNvPr>
          <p:cNvCxnSpPr/>
          <p:nvPr/>
        </p:nvCxnSpPr>
        <p:spPr>
          <a:xfrm>
            <a:off x="783396" y="2629748"/>
            <a:ext cx="1071563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A62DCA5-98E1-124D-8D75-79695C35F665}"/>
              </a:ext>
            </a:extLst>
          </p:cNvPr>
          <p:cNvCxnSpPr/>
          <p:nvPr/>
        </p:nvCxnSpPr>
        <p:spPr>
          <a:xfrm>
            <a:off x="1907989" y="2636479"/>
            <a:ext cx="1071562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108" descr="SAPK-JNKphos-CH-RE-0322.jpg">
            <a:extLst>
              <a:ext uri="{FF2B5EF4-FFF2-40B4-BE49-F238E27FC236}">
                <a16:creationId xmlns:a16="http://schemas.microsoft.com/office/drawing/2014/main" id="{7CE89981-804F-7E4B-BAC2-92186468B2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24"/>
          <a:stretch/>
        </p:blipFill>
        <p:spPr bwMode="auto">
          <a:xfrm>
            <a:off x="586546" y="3398134"/>
            <a:ext cx="2486706" cy="111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Box 16">
            <a:extLst>
              <a:ext uri="{FF2B5EF4-FFF2-40B4-BE49-F238E27FC236}">
                <a16:creationId xmlns:a16="http://schemas.microsoft.com/office/drawing/2014/main" id="{D92815A3-1193-074E-B40F-ABDC90DC2E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034" y="3326696"/>
            <a:ext cx="3254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/>
              <a:t>75</a:t>
            </a:r>
          </a:p>
        </p:txBody>
      </p:sp>
      <p:sp>
        <p:nvSpPr>
          <p:cNvPr id="33" name="TextBox 17">
            <a:extLst>
              <a:ext uri="{FF2B5EF4-FFF2-40B4-BE49-F238E27FC236}">
                <a16:creationId xmlns:a16="http://schemas.microsoft.com/office/drawing/2014/main" id="{CAB9A289-7BD7-3C4A-BD6D-2DE6936353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034" y="3612446"/>
            <a:ext cx="3254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/>
              <a:t>50</a:t>
            </a:r>
          </a:p>
        </p:txBody>
      </p:sp>
      <p:sp>
        <p:nvSpPr>
          <p:cNvPr id="34" name="TextBox 17">
            <a:extLst>
              <a:ext uri="{FF2B5EF4-FFF2-40B4-BE49-F238E27FC236}">
                <a16:creationId xmlns:a16="http://schemas.microsoft.com/office/drawing/2014/main" id="{96FE5A32-E55B-9046-AED6-22AEA54FCB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034" y="3866446"/>
            <a:ext cx="3254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/>
              <a:t>37</a:t>
            </a:r>
          </a:p>
        </p:txBody>
      </p:sp>
      <p:sp>
        <p:nvSpPr>
          <p:cNvPr id="35" name="TextBox 17">
            <a:extLst>
              <a:ext uri="{FF2B5EF4-FFF2-40B4-BE49-F238E27FC236}">
                <a16:creationId xmlns:a16="http://schemas.microsoft.com/office/drawing/2014/main" id="{C05E55EC-4E69-CC42-BF79-C90B2E2D5E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034" y="4276021"/>
            <a:ext cx="3254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/>
              <a:t>25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EAE8171B-3779-FC49-9F92-82A32C535C21}"/>
              </a:ext>
            </a:extLst>
          </p:cNvPr>
          <p:cNvGrpSpPr/>
          <p:nvPr/>
        </p:nvGrpSpPr>
        <p:grpSpPr>
          <a:xfrm>
            <a:off x="3113285" y="3685468"/>
            <a:ext cx="629588" cy="392661"/>
            <a:chOff x="3224863" y="2715172"/>
            <a:chExt cx="629588" cy="392661"/>
          </a:xfrm>
        </p:grpSpPr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60BC3DD8-82E9-0C4E-AB5B-A2B3761F89A3}"/>
                </a:ext>
              </a:extLst>
            </p:cNvPr>
            <p:cNvCxnSpPr/>
            <p:nvPr/>
          </p:nvCxnSpPr>
          <p:spPr>
            <a:xfrm>
              <a:off x="3224863" y="2959422"/>
              <a:ext cx="142875" cy="1587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24">
              <a:extLst>
                <a:ext uri="{FF2B5EF4-FFF2-40B4-BE49-F238E27FC236}">
                  <a16:creationId xmlns:a16="http://schemas.microsoft.com/office/drawing/2014/main" id="{BBBF8041-ADBF-A848-BAF3-69631E6881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97888" y="2830834"/>
              <a:ext cx="5565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A" altLang="en-US" sz="600" dirty="0"/>
                <a:t>Phos-p46</a:t>
              </a:r>
            </a:p>
            <a:p>
              <a:pPr eaLnBrk="1" hangingPunct="1"/>
              <a:r>
                <a:rPr lang="fr-CA" altLang="en-US" sz="600" dirty="0"/>
                <a:t>SAPK/JNK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9714B461-A9F2-354B-926A-01382B38983B}"/>
                </a:ext>
              </a:extLst>
            </p:cNvPr>
            <p:cNvCxnSpPr/>
            <p:nvPr/>
          </p:nvCxnSpPr>
          <p:spPr>
            <a:xfrm>
              <a:off x="3234388" y="2807022"/>
              <a:ext cx="142875" cy="1587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24">
              <a:extLst>
                <a:ext uri="{FF2B5EF4-FFF2-40B4-BE49-F238E27FC236}">
                  <a16:creationId xmlns:a16="http://schemas.microsoft.com/office/drawing/2014/main" id="{5B328EA0-2372-244F-80A2-B4CC29F20E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03331" y="2715172"/>
              <a:ext cx="5164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A" altLang="en-US" sz="600" dirty="0"/>
                <a:t>Phos-p54</a:t>
              </a:r>
            </a:p>
          </p:txBody>
        </p:sp>
      </p:grpSp>
      <p:sp>
        <p:nvSpPr>
          <p:cNvPr id="40" name="TextBox 21">
            <a:extLst>
              <a:ext uri="{FF2B5EF4-FFF2-40B4-BE49-F238E27FC236}">
                <a16:creationId xmlns:a16="http://schemas.microsoft.com/office/drawing/2014/main" id="{01EB05A1-C166-6947-A12C-FEEC7C83E9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9365" y="2092896"/>
            <a:ext cx="11817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b="1" dirty="0" err="1"/>
              <a:t>phos</a:t>
            </a:r>
            <a:r>
              <a:rPr lang="fr-CA" altLang="en-US" sz="1000" b="1" dirty="0"/>
              <a:t>-SAPK/JNK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50508997-BC98-6C4C-A056-7DCB6AE5BFBD}"/>
              </a:ext>
            </a:extLst>
          </p:cNvPr>
          <p:cNvGrpSpPr/>
          <p:nvPr/>
        </p:nvGrpSpPr>
        <p:grpSpPr>
          <a:xfrm>
            <a:off x="267459" y="4559280"/>
            <a:ext cx="3417778" cy="615950"/>
            <a:chOff x="362709" y="3870647"/>
            <a:chExt cx="3417778" cy="615950"/>
          </a:xfrm>
        </p:grpSpPr>
        <p:pic>
          <p:nvPicPr>
            <p:cNvPr id="41" name="Picture 145" descr="actin-RE-0310B.jpg">
              <a:extLst>
                <a:ext uri="{FF2B5EF4-FFF2-40B4-BE49-F238E27FC236}">
                  <a16:creationId xmlns:a16="http://schemas.microsoft.com/office/drawing/2014/main" id="{C5F1247A-D82C-7447-BB28-C8D8DE25F1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977"/>
            <a:stretch/>
          </p:blipFill>
          <p:spPr bwMode="auto">
            <a:xfrm>
              <a:off x="667509" y="3926209"/>
              <a:ext cx="2500993" cy="560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3" name="TextBox 17">
              <a:extLst>
                <a:ext uri="{FF2B5EF4-FFF2-40B4-BE49-F238E27FC236}">
                  <a16:creationId xmlns:a16="http://schemas.microsoft.com/office/drawing/2014/main" id="{7C76CD1E-0F68-504A-A96D-141F8C9EEC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2709" y="3870647"/>
              <a:ext cx="32543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A" altLang="en-US" sz="1000"/>
                <a:t>50</a:t>
              </a:r>
            </a:p>
          </p:txBody>
        </p:sp>
        <p:sp>
          <p:nvSpPr>
            <p:cNvPr id="44" name="TextBox 17">
              <a:extLst>
                <a:ext uri="{FF2B5EF4-FFF2-40B4-BE49-F238E27FC236}">
                  <a16:creationId xmlns:a16="http://schemas.microsoft.com/office/drawing/2014/main" id="{5810D5C5-5E02-D54E-B2B9-D51AE98EEB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2709" y="4221484"/>
              <a:ext cx="325437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A" altLang="en-US" sz="1000"/>
                <a:t>37</a:t>
              </a:r>
            </a:p>
          </p:txBody>
        </p: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515B5976-83E1-0A44-8D66-140737730B4B}"/>
                </a:ext>
              </a:extLst>
            </p:cNvPr>
            <p:cNvCxnSpPr/>
            <p:nvPr/>
          </p:nvCxnSpPr>
          <p:spPr>
            <a:xfrm>
              <a:off x="3139363" y="4150047"/>
              <a:ext cx="142875" cy="1587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24">
              <a:extLst>
                <a:ext uri="{FF2B5EF4-FFF2-40B4-BE49-F238E27FC236}">
                  <a16:creationId xmlns:a16="http://schemas.microsoft.com/office/drawing/2014/main" id="{96D82D49-5CDB-4B49-BB02-50449E2924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12162" y="4013522"/>
              <a:ext cx="56832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A" altLang="en-US" sz="1000">
                  <a:latin typeface="Symbol" charset="2"/>
                </a:rPr>
                <a:t>b</a:t>
              </a:r>
              <a:r>
                <a:rPr lang="fr-CA" altLang="en-US" sz="1000"/>
                <a:t>-actin</a:t>
              </a:r>
            </a:p>
          </p:txBody>
        </p:sp>
      </p:grp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FF34E87-10BA-464C-9EF5-2071D0F06C4D}"/>
              </a:ext>
            </a:extLst>
          </p:cNvPr>
          <p:cNvCxnSpPr>
            <a:cxnSpLocks/>
          </p:cNvCxnSpPr>
          <p:nvPr/>
        </p:nvCxnSpPr>
        <p:spPr>
          <a:xfrm flipH="1">
            <a:off x="1887615" y="2435919"/>
            <a:ext cx="10287" cy="2828314"/>
          </a:xfrm>
          <a:prstGeom prst="line">
            <a:avLst/>
          </a:prstGeom>
          <a:ln w="3175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4">
            <a:extLst>
              <a:ext uri="{FF2B5EF4-FFF2-40B4-BE49-F238E27FC236}">
                <a16:creationId xmlns:a16="http://schemas.microsoft.com/office/drawing/2014/main" id="{69C260FE-D7B3-0444-83E5-B22CE04D3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834" y="2435919"/>
            <a:ext cx="95731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Choroid</a:t>
            </a:r>
            <a:r>
              <a:rPr lang="fr-CA" altLang="en-US" sz="800" dirty="0"/>
              <a:t> </a:t>
            </a:r>
            <a:r>
              <a:rPr lang="fr-CA" altLang="en-US" sz="800" dirty="0" err="1"/>
              <a:t>samples</a:t>
            </a:r>
            <a:endParaRPr lang="fr-CA" altLang="en-US" sz="800" dirty="0"/>
          </a:p>
        </p:txBody>
      </p:sp>
      <p:sp>
        <p:nvSpPr>
          <p:cNvPr id="57" name="TextBox 4">
            <a:extLst>
              <a:ext uri="{FF2B5EF4-FFF2-40B4-BE49-F238E27FC236}">
                <a16:creationId xmlns:a16="http://schemas.microsoft.com/office/drawing/2014/main" id="{5B324847-1404-0743-89AA-B2A46CA55E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1065" y="2439432"/>
            <a:ext cx="91723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800" dirty="0" err="1"/>
              <a:t>Retinal</a:t>
            </a:r>
            <a:r>
              <a:rPr lang="fr-CA" altLang="en-US" sz="800" dirty="0"/>
              <a:t> </a:t>
            </a:r>
            <a:r>
              <a:rPr lang="fr-CA" altLang="en-US" sz="800" dirty="0" err="1"/>
              <a:t>samples</a:t>
            </a:r>
            <a:endParaRPr lang="fr-CA" altLang="en-US" sz="800" dirty="0"/>
          </a:p>
        </p:txBody>
      </p:sp>
      <p:sp>
        <p:nvSpPr>
          <p:cNvPr id="115" name="TextBox 21">
            <a:extLst>
              <a:ext uri="{FF2B5EF4-FFF2-40B4-BE49-F238E27FC236}">
                <a16:creationId xmlns:a16="http://schemas.microsoft.com/office/drawing/2014/main" id="{36B20066-1F8A-B945-9E6B-7F96B71CCE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8822" y="1879628"/>
            <a:ext cx="5571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b="1" dirty="0"/>
              <a:t>A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6000"/>
                    </a14:imgEffect>
                    <a14:imgEffect>
                      <a14:brightnessContrast bright="40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956" t="20186" b="18671"/>
          <a:stretch/>
        </p:blipFill>
        <p:spPr>
          <a:xfrm>
            <a:off x="6344422" y="2310911"/>
            <a:ext cx="2044276" cy="2601604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10" t="25177" b="25329"/>
          <a:stretch/>
        </p:blipFill>
        <p:spPr>
          <a:xfrm>
            <a:off x="8683366" y="2310911"/>
            <a:ext cx="2391906" cy="2368169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5222675" y="2822887"/>
            <a:ext cx="11448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 err="1"/>
              <a:t>Phos</a:t>
            </a:r>
            <a:r>
              <a:rPr lang="fr-CA" sz="1600" dirty="0"/>
              <a:t>-NF-</a:t>
            </a:r>
            <a:r>
              <a:rPr lang="fr-CA" sz="1600" dirty="0" err="1"/>
              <a:t>kB</a:t>
            </a:r>
            <a:endParaRPr lang="fr-CA" sz="16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0689079" y="3771410"/>
            <a:ext cx="7873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>
                <a:sym typeface="Symbol" panose="05050102010706020507" pitchFamily="18" charset="2"/>
              </a:rPr>
              <a:t></a:t>
            </a:r>
            <a:r>
              <a:rPr lang="fr-CA" sz="1600" dirty="0"/>
              <a:t>-</a:t>
            </a:r>
            <a:r>
              <a:rPr lang="fr-CA" sz="1600" dirty="0" err="1"/>
              <a:t>Actin</a:t>
            </a:r>
            <a:endParaRPr lang="fr-CA" sz="1600" dirty="0"/>
          </a:p>
        </p:txBody>
      </p:sp>
      <p:sp>
        <p:nvSpPr>
          <p:cNvPr id="86" name="TextBox 4">
            <a:extLst>
              <a:ext uri="{FF2B5EF4-FFF2-40B4-BE49-F238E27FC236}">
                <a16:creationId xmlns:a16="http://schemas.microsoft.com/office/drawing/2014/main" id="{EBFEF35D-E528-FC40-BB86-AAC5A22F118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811539" y="2236177"/>
            <a:ext cx="4122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dirty="0"/>
              <a:t>OIR</a:t>
            </a:r>
          </a:p>
        </p:txBody>
      </p:sp>
      <p:sp>
        <p:nvSpPr>
          <p:cNvPr id="90" name="TextBox 4">
            <a:extLst>
              <a:ext uri="{FF2B5EF4-FFF2-40B4-BE49-F238E27FC236}">
                <a16:creationId xmlns:a16="http://schemas.microsoft.com/office/drawing/2014/main" id="{BBEA7541-7053-5146-AF3B-6FDE63929EA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767770" y="2020783"/>
            <a:ext cx="86433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dirty="0" err="1"/>
              <a:t>OIR+rytvela</a:t>
            </a:r>
            <a:endParaRPr lang="fr-CA" altLang="en-US" sz="1000" dirty="0"/>
          </a:p>
        </p:txBody>
      </p:sp>
      <p:sp>
        <p:nvSpPr>
          <p:cNvPr id="91" name="TextBox 4">
            <a:extLst>
              <a:ext uri="{FF2B5EF4-FFF2-40B4-BE49-F238E27FC236}">
                <a16:creationId xmlns:a16="http://schemas.microsoft.com/office/drawing/2014/main" id="{AF2FB1A9-146D-004C-BACF-9FDEFB5B892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952417" y="2008021"/>
            <a:ext cx="89159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dirty="0" err="1"/>
              <a:t>OIR+Kineret</a:t>
            </a:r>
            <a:endParaRPr lang="fr-CA" altLang="en-US" sz="1000" dirty="0"/>
          </a:p>
        </p:txBody>
      </p:sp>
      <p:sp>
        <p:nvSpPr>
          <p:cNvPr id="92" name="TextBox 4">
            <a:extLst>
              <a:ext uri="{FF2B5EF4-FFF2-40B4-BE49-F238E27FC236}">
                <a16:creationId xmlns:a16="http://schemas.microsoft.com/office/drawing/2014/main" id="{FFCF6F72-F104-8645-9980-685AEB4310A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581554" y="2206934"/>
            <a:ext cx="470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dirty="0"/>
              <a:t>NOR</a:t>
            </a:r>
          </a:p>
        </p:txBody>
      </p:sp>
      <p:sp>
        <p:nvSpPr>
          <p:cNvPr id="93" name="ZoneTexte 6">
            <a:extLst>
              <a:ext uri="{FF2B5EF4-FFF2-40B4-BE49-F238E27FC236}">
                <a16:creationId xmlns:a16="http://schemas.microsoft.com/office/drawing/2014/main" id="{3CC93176-1461-3047-AC53-7FC5F2AABA4F}"/>
              </a:ext>
            </a:extLst>
          </p:cNvPr>
          <p:cNvSpPr txBox="1"/>
          <p:nvPr/>
        </p:nvSpPr>
        <p:spPr>
          <a:xfrm>
            <a:off x="4655738" y="3159042"/>
            <a:ext cx="17620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Non-</a:t>
            </a:r>
            <a:r>
              <a:rPr lang="fr-CA" sz="1600" dirty="0" err="1"/>
              <a:t>specific</a:t>
            </a:r>
            <a:r>
              <a:rPr lang="fr-CA" sz="1600" dirty="0"/>
              <a:t> bands</a:t>
            </a:r>
          </a:p>
        </p:txBody>
      </p:sp>
      <p:sp>
        <p:nvSpPr>
          <p:cNvPr id="50" name="TextBox 21">
            <a:extLst>
              <a:ext uri="{FF2B5EF4-FFF2-40B4-BE49-F238E27FC236}">
                <a16:creationId xmlns:a16="http://schemas.microsoft.com/office/drawing/2014/main" id="{5DE389A2-DB2B-4931-BE10-B864F508BA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3102" y="2030030"/>
            <a:ext cx="5571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A" altLang="en-US" sz="1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65258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3</TotalTime>
  <Words>74</Words>
  <Application>Microsoft Macintosh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Supplementary material - Original western blots (Fig. 4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western blots</dc:title>
  <dc:creator>Ellen Zhou</dc:creator>
  <cp:lastModifiedBy>Sayah Diane Noël</cp:lastModifiedBy>
  <cp:revision>27</cp:revision>
  <dcterms:created xsi:type="dcterms:W3CDTF">2019-11-20T00:13:19Z</dcterms:created>
  <dcterms:modified xsi:type="dcterms:W3CDTF">2020-03-03T04:03:50Z</dcterms:modified>
</cp:coreProperties>
</file>